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75" r:id="rId3"/>
    <p:sldId id="280" r:id="rId4"/>
    <p:sldId id="271" r:id="rId5"/>
    <p:sldId id="282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47" autoAdjust="0"/>
    <p:restoredTop sz="98627" autoAdjust="0"/>
  </p:normalViewPr>
  <p:slideViewPr>
    <p:cSldViewPr>
      <p:cViewPr varScale="1">
        <p:scale>
          <a:sx n="81" d="100"/>
          <a:sy n="81" d="100"/>
        </p:scale>
        <p:origin x="3546" y="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njsg\Desktop\thesis%20result%20figure%20&amp;%20table\COG%20annotation%20of%20strain%20B-1662%20genom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3027749127964092E-2"/>
          <c:y val="6.1524759924144287E-2"/>
          <c:w val="0.54200238731626438"/>
          <c:h val="0.7954358930940084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rgbClr val="FF669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FE7-4E1C-8E25-A4C03DE2148F}"/>
              </c:ext>
            </c:extLst>
          </c:dPt>
          <c:dPt>
            <c:idx val="3"/>
            <c:invertIfNegative val="0"/>
            <c:bubble3D val="0"/>
            <c:spPr>
              <a:solidFill>
                <a:srgbClr val="CC00CC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FE7-4E1C-8E25-A4C03DE2148F}"/>
              </c:ext>
            </c:extLst>
          </c:dPt>
          <c:dPt>
            <c:idx val="4"/>
            <c:invertIfNegative val="0"/>
            <c:bubble3D val="0"/>
            <c:spPr>
              <a:solidFill>
                <a:srgbClr val="FFCC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FE7-4E1C-8E25-A4C03DE2148F}"/>
              </c:ext>
            </c:extLst>
          </c:dPt>
          <c:dPt>
            <c:idx val="5"/>
            <c:invertIfNegative val="0"/>
            <c:bubble3D val="0"/>
            <c:spPr>
              <a:solidFill>
                <a:srgbClr val="FF993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FE7-4E1C-8E25-A4C03DE2148F}"/>
              </c:ext>
            </c:extLst>
          </c:dPt>
          <c:dPt>
            <c:idx val="6"/>
            <c:invertIfNegative val="0"/>
            <c:bubble3D val="0"/>
            <c:spPr>
              <a:solidFill>
                <a:srgbClr val="FF66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FE7-4E1C-8E25-A4C03DE2148F}"/>
              </c:ext>
            </c:extLst>
          </c:dPt>
          <c:dPt>
            <c:idx val="7"/>
            <c:invertIfNegative val="0"/>
            <c:bubble3D val="0"/>
            <c:spPr>
              <a:solidFill>
                <a:srgbClr val="FF33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FE7-4E1C-8E25-A4C03DE2148F}"/>
              </c:ext>
            </c:extLst>
          </c:dPt>
          <c:dPt>
            <c:idx val="8"/>
            <c:invertIfNegative val="0"/>
            <c:bubble3D val="0"/>
            <c:spPr>
              <a:solidFill>
                <a:srgbClr val="FFFFCC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0FE7-4E1C-8E25-A4C03DE2148F}"/>
              </c:ext>
            </c:extLst>
          </c:dPt>
          <c:dPt>
            <c:idx val="9"/>
            <c:invertIfNegative val="0"/>
            <c:bubble3D val="0"/>
            <c:spPr>
              <a:solidFill>
                <a:srgbClr val="FFFF6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0FE7-4E1C-8E25-A4C03DE2148F}"/>
              </c:ext>
            </c:extLst>
          </c:dPt>
          <c:dPt>
            <c:idx val="10"/>
            <c:invertIfNegative val="0"/>
            <c:bubble3D val="0"/>
            <c:spPr>
              <a:solidFill>
                <a:srgbClr val="CCCC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0FE7-4E1C-8E25-A4C03DE2148F}"/>
              </c:ext>
            </c:extLst>
          </c:dPt>
          <c:dPt>
            <c:idx val="11"/>
            <c:invertIfNegative val="0"/>
            <c:bubble3D val="0"/>
            <c:spPr>
              <a:solidFill>
                <a:srgbClr val="CCFFCC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0FE7-4E1C-8E25-A4C03DE2148F}"/>
              </c:ext>
            </c:extLst>
          </c:dPt>
          <c:dPt>
            <c:idx val="12"/>
            <c:invertIfNegative val="0"/>
            <c:bubble3D val="0"/>
            <c:spPr>
              <a:solidFill>
                <a:srgbClr val="66FF9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0FE7-4E1C-8E25-A4C03DE2148F}"/>
              </c:ext>
            </c:extLst>
          </c:dPt>
          <c:dPt>
            <c:idx val="14"/>
            <c:invertIfNegative val="0"/>
            <c:bubble3D val="0"/>
            <c:spPr>
              <a:solidFill>
                <a:srgbClr val="0099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0FE7-4E1C-8E25-A4C03DE2148F}"/>
              </c:ext>
            </c:extLst>
          </c:dPt>
          <c:dPt>
            <c:idx val="15"/>
            <c:invertIfNegative val="0"/>
            <c:bubble3D val="0"/>
            <c:spPr>
              <a:solidFill>
                <a:srgbClr val="CC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0FE7-4E1C-8E25-A4C03DE2148F}"/>
              </c:ext>
            </c:extLst>
          </c:dPt>
          <c:dPt>
            <c:idx val="16"/>
            <c:invertIfNegative val="0"/>
            <c:bubble3D val="0"/>
            <c:spPr>
              <a:solidFill>
                <a:srgbClr val="66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0FE7-4E1C-8E25-A4C03DE2148F}"/>
              </c:ext>
            </c:extLst>
          </c:dPt>
          <c:dPt>
            <c:idx val="17"/>
            <c:invertIfNegative val="0"/>
            <c:bubble3D val="0"/>
            <c:spPr>
              <a:solidFill>
                <a:srgbClr val="33CC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0FE7-4E1C-8E25-A4C03DE2148F}"/>
              </c:ext>
            </c:extLst>
          </c:dPt>
          <c:dPt>
            <c:idx val="18"/>
            <c:invertIfNegative val="0"/>
            <c:bubble3D val="0"/>
            <c:spPr>
              <a:solidFill>
                <a:srgbClr val="0099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0FE7-4E1C-8E25-A4C03DE2148F}"/>
              </c:ext>
            </c:extLst>
          </c:dPt>
          <c:dPt>
            <c:idx val="19"/>
            <c:invertIfNegative val="0"/>
            <c:bubble3D val="0"/>
            <c:spPr>
              <a:solidFill>
                <a:srgbClr val="0033CC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0FE7-4E1C-8E25-A4C03DE2148F}"/>
              </c:ext>
            </c:extLst>
          </c:dPt>
          <c:dPt>
            <c:idx val="20"/>
            <c:invertIfNegative val="0"/>
            <c:bubble3D val="0"/>
            <c:spPr>
              <a:solidFill>
                <a:srgbClr val="CCCC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0FE7-4E1C-8E25-A4C03DE2148F}"/>
              </c:ext>
            </c:extLst>
          </c:dPt>
          <c:dPt>
            <c:idx val="21"/>
            <c:invertIfNegative val="0"/>
            <c:bubble3D val="0"/>
            <c:spPr>
              <a:solidFill>
                <a:srgbClr val="CC99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0FE7-4E1C-8E25-A4C03DE2148F}"/>
              </c:ext>
            </c:extLst>
          </c:dPt>
          <c:cat>
            <c:strRef>
              <c:f>'COG annotation of strain B-1662'!$F$3:$F$27</c:f>
              <c:strCache>
                <c:ptCount val="25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  <c:pt idx="17">
                  <c:v>R</c:v>
                </c:pt>
                <c:pt idx="18">
                  <c:v>S</c:v>
                </c:pt>
                <c:pt idx="19">
                  <c:v>T</c:v>
                </c:pt>
                <c:pt idx="20">
                  <c:v>U</c:v>
                </c:pt>
                <c:pt idx="21">
                  <c:v>V</c:v>
                </c:pt>
                <c:pt idx="22">
                  <c:v>W</c:v>
                </c:pt>
                <c:pt idx="23">
                  <c:v>Y</c:v>
                </c:pt>
                <c:pt idx="24">
                  <c:v>Z</c:v>
                </c:pt>
              </c:strCache>
            </c:strRef>
          </c:cat>
          <c:val>
            <c:numRef>
              <c:f>'COG annotation of strain B-1662'!$G$3:$G$27</c:f>
              <c:numCache>
                <c:formatCode>General</c:formatCode>
                <c:ptCount val="25"/>
                <c:pt idx="0">
                  <c:v>1</c:v>
                </c:pt>
                <c:pt idx="1">
                  <c:v>1</c:v>
                </c:pt>
                <c:pt idx="2">
                  <c:v>294</c:v>
                </c:pt>
                <c:pt idx="3">
                  <c:v>30</c:v>
                </c:pt>
                <c:pt idx="4">
                  <c:v>394</c:v>
                </c:pt>
                <c:pt idx="5">
                  <c:v>98</c:v>
                </c:pt>
                <c:pt idx="6">
                  <c:v>308</c:v>
                </c:pt>
                <c:pt idx="7">
                  <c:v>147</c:v>
                </c:pt>
                <c:pt idx="8">
                  <c:v>200</c:v>
                </c:pt>
                <c:pt idx="9">
                  <c:v>189</c:v>
                </c:pt>
                <c:pt idx="10">
                  <c:v>566</c:v>
                </c:pt>
                <c:pt idx="11">
                  <c:v>224</c:v>
                </c:pt>
                <c:pt idx="12">
                  <c:v>193</c:v>
                </c:pt>
                <c:pt idx="13">
                  <c:v>1</c:v>
                </c:pt>
                <c:pt idx="14">
                  <c:v>163</c:v>
                </c:pt>
                <c:pt idx="15">
                  <c:v>232</c:v>
                </c:pt>
                <c:pt idx="16">
                  <c:v>172</c:v>
                </c:pt>
                <c:pt idx="17">
                  <c:v>1284</c:v>
                </c:pt>
                <c:pt idx="18">
                  <c:v>2179</c:v>
                </c:pt>
                <c:pt idx="19">
                  <c:v>320</c:v>
                </c:pt>
                <c:pt idx="20">
                  <c:v>31</c:v>
                </c:pt>
                <c:pt idx="21">
                  <c:v>103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0FE7-4E1C-8E25-A4C03DE214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71675648"/>
        <c:axId val="632999872"/>
      </c:barChart>
      <c:catAx>
        <c:axId val="7716756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 sz="1100" baseline="0" dirty="0">
                    <a:solidFill>
                      <a:schemeClr val="tx1"/>
                    </a:solidFill>
                  </a:rPr>
                  <a:t>COG functional category</a:t>
                </a:r>
                <a:endParaRPr lang="ko-KR" sz="1100" baseline="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ko-KR"/>
          </a:p>
        </c:txPr>
        <c:crossAx val="632999872"/>
        <c:crosses val="autoZero"/>
        <c:auto val="1"/>
        <c:lblAlgn val="ctr"/>
        <c:lblOffset val="100"/>
        <c:noMultiLvlLbl val="0"/>
      </c:catAx>
      <c:valAx>
        <c:axId val="6329998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ko-KR"/>
          </a:p>
        </c:txPr>
        <c:crossAx val="7716756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>
          <a:latin typeface="Times New Roman" panose="02020603050405020304" pitchFamily="18" charset="0"/>
        </a:defRPr>
      </a:pPr>
      <a:endParaRPr lang="ko-K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10" Type="http://schemas.openxmlformats.org/officeDocument/2006/relationships/image" Target="../media/image15.jpeg"/><Relationship Id="rId4" Type="http://schemas.openxmlformats.org/officeDocument/2006/relationships/image" Target="../media/image9.jpeg"/><Relationship Id="rId9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0A1F4FFA-04B2-0379-7101-FBFFD754A68D}"/>
              </a:ext>
            </a:extLst>
          </p:cNvPr>
          <p:cNvSpPr txBox="1"/>
          <p:nvPr/>
        </p:nvSpPr>
        <p:spPr>
          <a:xfrm>
            <a:off x="609600" y="4953000"/>
            <a:ext cx="5638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ltural characteristic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oroverrucosu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-1662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various ISP media, such as ISP 1 (A), ISP 2 (B), ISP 3 (C), ISP 4 (D), ISP 5 (E), and R2A medium (F). Images were captured 3 days after incubation a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°C.</a:t>
            </a:r>
            <a:endParaRPr lang="en-US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954367" y="457200"/>
            <a:ext cx="2772093" cy="4155464"/>
            <a:chOff x="1954367" y="457200"/>
            <a:chExt cx="2772093" cy="4155464"/>
          </a:xfrm>
        </p:grpSpPr>
        <p:pic>
          <p:nvPicPr>
            <p:cNvPr id="4" name="그림 4" descr="테이블웨어, 원, 식기이(가) 표시된 사진&#10;&#10;자동 생성된 설명">
              <a:extLst>
                <a:ext uri="{FF2B5EF4-FFF2-40B4-BE49-F238E27FC236}">
                  <a16:creationId xmlns:a16="http://schemas.microsoft.com/office/drawing/2014/main" id="{55BECA6E-D553-35AC-F83C-799E72632E4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54367" y="457200"/>
              <a:ext cx="1371600" cy="1371600"/>
            </a:xfrm>
            <a:prstGeom prst="rect">
              <a:avLst/>
            </a:prstGeom>
          </p:spPr>
        </p:pic>
        <p:pic>
          <p:nvPicPr>
            <p:cNvPr id="5" name="그림 6" descr="원, 테이블웨어, 식기이(가) 표시된 사진&#10;&#10;자동 생성된 설명">
              <a:extLst>
                <a:ext uri="{FF2B5EF4-FFF2-40B4-BE49-F238E27FC236}">
                  <a16:creationId xmlns:a16="http://schemas.microsoft.com/office/drawing/2014/main" id="{172E3519-50FB-A183-D7EF-5B4C4AA5975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50893" y="457200"/>
              <a:ext cx="1371600" cy="1371600"/>
            </a:xfrm>
            <a:prstGeom prst="rect">
              <a:avLst/>
            </a:prstGeom>
          </p:spPr>
        </p:pic>
        <p:pic>
          <p:nvPicPr>
            <p:cNvPr id="6" name="그림 8" descr="테이블웨어, 원, 식기이(가) 표시된 사진&#10;&#10;자동 생성된 설명">
              <a:extLst>
                <a:ext uri="{FF2B5EF4-FFF2-40B4-BE49-F238E27FC236}">
                  <a16:creationId xmlns:a16="http://schemas.microsoft.com/office/drawing/2014/main" id="{2F29CA93-9095-29B6-DD4C-3CD7FD7DA55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54367" y="1851660"/>
              <a:ext cx="1372057" cy="1371601"/>
            </a:xfrm>
            <a:prstGeom prst="rect">
              <a:avLst/>
            </a:prstGeom>
          </p:spPr>
        </p:pic>
        <p:pic>
          <p:nvPicPr>
            <p:cNvPr id="7" name="그림 12" descr="원, 테이블웨어, 식기이(가) 표시된 사진&#10;&#10;자동 생성된 설명">
              <a:extLst>
                <a:ext uri="{FF2B5EF4-FFF2-40B4-BE49-F238E27FC236}">
                  <a16:creationId xmlns:a16="http://schemas.microsoft.com/office/drawing/2014/main" id="{BBA8B83D-69C4-ED54-1A82-0115BB5D5B1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52342" y="1849757"/>
              <a:ext cx="1372058" cy="1372058"/>
            </a:xfrm>
            <a:prstGeom prst="rect">
              <a:avLst/>
            </a:prstGeom>
          </p:spPr>
        </p:pic>
        <p:pic>
          <p:nvPicPr>
            <p:cNvPr id="8" name="그림 16" descr="테이블웨어, 원, 식기이(가) 표시된 사진&#10;&#10;자동 생성된 설명">
              <a:extLst>
                <a:ext uri="{FF2B5EF4-FFF2-40B4-BE49-F238E27FC236}">
                  <a16:creationId xmlns:a16="http://schemas.microsoft.com/office/drawing/2014/main" id="{C16AA02E-70CF-6BDA-0B84-31B0FCEF4D1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54367" y="3241064"/>
              <a:ext cx="1371600" cy="1371600"/>
            </a:xfrm>
            <a:prstGeom prst="rect">
              <a:avLst/>
            </a:prstGeom>
          </p:spPr>
        </p:pic>
        <p:pic>
          <p:nvPicPr>
            <p:cNvPr id="9" name="그림 18" descr="원, 테이블웨어, 식기이(가) 표시된 사진&#10;&#10;자동 생성된 설명">
              <a:extLst>
                <a:ext uri="{FF2B5EF4-FFF2-40B4-BE49-F238E27FC236}">
                  <a16:creationId xmlns:a16="http://schemas.microsoft.com/office/drawing/2014/main" id="{96D20073-385E-4388-2EF5-057B8FB4D01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54860" y="3238499"/>
              <a:ext cx="1371600" cy="137160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23DC6BE-7174-4708-9F81-66666D986B62}"/>
                </a:ext>
              </a:extLst>
            </p:cNvPr>
            <p:cNvSpPr txBox="1"/>
            <p:nvPr/>
          </p:nvSpPr>
          <p:spPr>
            <a:xfrm>
              <a:off x="1960717" y="457200"/>
              <a:ext cx="323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ko-KR" alt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23DC6BE-7174-4708-9F81-66666D986B62}"/>
                </a:ext>
              </a:extLst>
            </p:cNvPr>
            <p:cNvSpPr txBox="1"/>
            <p:nvPr/>
          </p:nvSpPr>
          <p:spPr>
            <a:xfrm>
              <a:off x="3350893" y="457200"/>
              <a:ext cx="323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ko-KR" alt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23DC6BE-7174-4708-9F81-66666D986B62}"/>
                </a:ext>
              </a:extLst>
            </p:cNvPr>
            <p:cNvSpPr txBox="1"/>
            <p:nvPr/>
          </p:nvSpPr>
          <p:spPr>
            <a:xfrm>
              <a:off x="1955637" y="1858009"/>
              <a:ext cx="323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ko-KR" alt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23DC6BE-7174-4708-9F81-66666D986B62}"/>
                </a:ext>
              </a:extLst>
            </p:cNvPr>
            <p:cNvSpPr txBox="1"/>
            <p:nvPr/>
          </p:nvSpPr>
          <p:spPr>
            <a:xfrm>
              <a:off x="3351072" y="1854517"/>
              <a:ext cx="323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ko-KR" alt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23DC6BE-7174-4708-9F81-66666D986B62}"/>
                </a:ext>
              </a:extLst>
            </p:cNvPr>
            <p:cNvSpPr txBox="1"/>
            <p:nvPr/>
          </p:nvSpPr>
          <p:spPr>
            <a:xfrm>
              <a:off x="1960379" y="3242968"/>
              <a:ext cx="323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ko-KR" alt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23DC6BE-7174-4708-9F81-66666D986B62}"/>
                </a:ext>
              </a:extLst>
            </p:cNvPr>
            <p:cNvSpPr txBox="1"/>
            <p:nvPr/>
          </p:nvSpPr>
          <p:spPr>
            <a:xfrm>
              <a:off x="3357717" y="3241673"/>
              <a:ext cx="323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ko-KR" alt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937517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195955" y="4579203"/>
            <a:ext cx="6477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antifungal effects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tomyces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oroverrucosu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1662 bacteria suspensions agains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amense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CP6 when exposed to various physical stress conditions, such as UV light, and different temperatures (-20°C, 37°C, 50°C, 70°C, and 100°C). Images were captured after incubation of plates for 9 days at 25°C.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51460" y="1200150"/>
            <a:ext cx="6301740" cy="3145921"/>
            <a:chOff x="251460" y="1200150"/>
            <a:chExt cx="6301740" cy="3145921"/>
          </a:xfrm>
        </p:grpSpPr>
        <p:pic>
          <p:nvPicPr>
            <p:cNvPr id="5" name="그림 1698152336" descr="테이블웨어, 원, 식기이(가) 표시된 사진&#10;&#10;자동 생성된 설명">
              <a:extLst>
                <a:ext uri="{FF2B5EF4-FFF2-40B4-BE49-F238E27FC236}">
                  <a16:creationId xmlns:a16="http://schemas.microsoft.com/office/drawing/2014/main" id="{AAACD5B6-EB45-2C66-EDE4-24EB155D667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3135" y="1484767"/>
              <a:ext cx="1232285" cy="1249039"/>
            </a:xfrm>
            <a:prstGeom prst="rect">
              <a:avLst/>
            </a:prstGeom>
          </p:spPr>
        </p:pic>
        <p:pic>
          <p:nvPicPr>
            <p:cNvPr id="7" name="그림 1698152338" descr="원, 테이블웨어, 식기이(가) 표시된 사진&#10;&#10;자동 생성된 설명">
              <a:extLst>
                <a:ext uri="{FF2B5EF4-FFF2-40B4-BE49-F238E27FC236}">
                  <a16:creationId xmlns:a16="http://schemas.microsoft.com/office/drawing/2014/main" id="{DA40A4CC-BE1A-BCB3-0071-8EEB34F7764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64971" y="1484764"/>
              <a:ext cx="1232289" cy="1249042"/>
            </a:xfrm>
            <a:prstGeom prst="rect">
              <a:avLst/>
            </a:prstGeom>
          </p:spPr>
        </p:pic>
        <p:pic>
          <p:nvPicPr>
            <p:cNvPr id="8" name="그림 1698152339" descr="테이블웨어, 식기, 실내이(가) 표시된 사진&#10;&#10;자동 생성된 설명">
              <a:extLst>
                <a:ext uri="{FF2B5EF4-FFF2-40B4-BE49-F238E27FC236}">
                  <a16:creationId xmlns:a16="http://schemas.microsoft.com/office/drawing/2014/main" id="{9276960E-F7A0-2AC7-A95F-AA7DF04B898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13114" y="1484761"/>
              <a:ext cx="1232285" cy="1249039"/>
            </a:xfrm>
            <a:prstGeom prst="rect">
              <a:avLst/>
            </a:prstGeom>
          </p:spPr>
        </p:pic>
        <p:pic>
          <p:nvPicPr>
            <p:cNvPr id="9" name="그림 1698152340" descr="실내이(가) 표시된 사진&#10;&#10;자동 생성된 설명">
              <a:extLst>
                <a:ext uri="{FF2B5EF4-FFF2-40B4-BE49-F238E27FC236}">
                  <a16:creationId xmlns:a16="http://schemas.microsoft.com/office/drawing/2014/main" id="{2B583446-A2CE-1900-19F6-D8261DB9D9A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9080" y="1484770"/>
              <a:ext cx="1232285" cy="1249033"/>
            </a:xfrm>
            <a:prstGeom prst="rect">
              <a:avLst/>
            </a:prstGeom>
          </p:spPr>
        </p:pic>
        <p:pic>
          <p:nvPicPr>
            <p:cNvPr id="6" name="그림 1698152337" descr="테이블웨어, 원, 식기이(가) 표시된 사진&#10;&#10;자동 생성된 설명">
              <a:extLst>
                <a:ext uri="{FF2B5EF4-FFF2-40B4-BE49-F238E27FC236}">
                  <a16:creationId xmlns:a16="http://schemas.microsoft.com/office/drawing/2014/main" id="{E5FDCB28-76A4-1E43-50D0-4152B50C5F9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" y="3024692"/>
              <a:ext cx="1238335" cy="1321373"/>
            </a:xfrm>
            <a:prstGeom prst="rect">
              <a:avLst/>
            </a:prstGeom>
          </p:spPr>
        </p:pic>
        <p:pic>
          <p:nvPicPr>
            <p:cNvPr id="10" name="그림 1698152341" descr="실내, 테이블웨어이(가) 표시된 사진&#10;&#10;자동 생성된 설명">
              <a:extLst>
                <a:ext uri="{FF2B5EF4-FFF2-40B4-BE49-F238E27FC236}">
                  <a16:creationId xmlns:a16="http://schemas.microsoft.com/office/drawing/2014/main" id="{3EA084C7-CBC8-7CC7-DF5A-0172068349C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13856" y="3024693"/>
              <a:ext cx="1238337" cy="1318142"/>
            </a:xfrm>
            <a:prstGeom prst="rect">
              <a:avLst/>
            </a:prstGeom>
          </p:spPr>
        </p:pic>
        <p:pic>
          <p:nvPicPr>
            <p:cNvPr id="11" name="그림 1698152342" descr="테이블웨어, 실내, 식기이(가) 표시된 사진&#10;&#10;자동 생성된 설명">
              <a:extLst>
                <a:ext uri="{FF2B5EF4-FFF2-40B4-BE49-F238E27FC236}">
                  <a16:creationId xmlns:a16="http://schemas.microsoft.com/office/drawing/2014/main" id="{DBAC370D-D0A4-CB22-8BB9-3CDEA9487AB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3933" y="3024693"/>
              <a:ext cx="1238338" cy="1321378"/>
            </a:xfrm>
            <a:prstGeom prst="rect">
              <a:avLst/>
            </a:prstGeom>
          </p:spPr>
        </p:pic>
        <p:pic>
          <p:nvPicPr>
            <p:cNvPr id="12" name="그림 1698152343" descr="테이블웨어, 식기이(가) 표시된 사진&#10;&#10;자동 생성된 설명">
              <a:extLst>
                <a:ext uri="{FF2B5EF4-FFF2-40B4-BE49-F238E27FC236}">
                  <a16:creationId xmlns:a16="http://schemas.microsoft.com/office/drawing/2014/main" id="{4E3D310C-DCF6-DF33-556E-E4D3F5EB030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42091" y="3024693"/>
              <a:ext cx="1238335" cy="1318142"/>
            </a:xfrm>
            <a:prstGeom prst="rect">
              <a:avLst/>
            </a:prstGeom>
          </p:spPr>
        </p:pic>
        <p:pic>
          <p:nvPicPr>
            <p:cNvPr id="13" name="그림 1698152344" descr="테이블웨어, 식기이(가) 표시된 사진&#10;&#10;자동 생성된 설명">
              <a:extLst>
                <a:ext uri="{FF2B5EF4-FFF2-40B4-BE49-F238E27FC236}">
                  <a16:creationId xmlns:a16="http://schemas.microsoft.com/office/drawing/2014/main" id="{2B47D00A-BE35-5DCB-F0DB-65AA36BF731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14862" y="3024693"/>
              <a:ext cx="1238338" cy="1321378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551415" y="1202821"/>
              <a:ext cx="655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869575" y="1200151"/>
              <a:ext cx="5421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/>
                  <a:ea typeface="맑은 고딕"/>
                  <a:cs typeface="굴림"/>
                </a:rPr>
                <a:t>CF </a:t>
              </a:r>
              <a:r>
                <a:rPr lang="en-US" sz="1200" baseline="30000" dirty="0">
                  <a:solidFill>
                    <a:srgbClr val="000000"/>
                  </a:solidFill>
                  <a:latin typeface="Times New Roman"/>
                  <a:ea typeface="맑은 고딕"/>
                  <a:cs typeface="굴림"/>
                </a:rPr>
                <a:t>5th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178175" y="120015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/>
                  <a:ea typeface="맑은 고딕"/>
                  <a:cs typeface="굴림"/>
                </a:rPr>
                <a:t>UV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387785" y="1200150"/>
              <a:ext cx="5469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/>
                  <a:ea typeface="맑은 고딕"/>
                  <a:cs typeface="굴림"/>
                </a:rPr>
                <a:t>-20℃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42274" y="2773811"/>
              <a:ext cx="4956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/>
                  <a:ea typeface="맑은 고딕"/>
                  <a:cs typeface="굴림"/>
                </a:rPr>
                <a:t>37℃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884815" y="2775634"/>
              <a:ext cx="4956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/>
                  <a:ea typeface="맑은 고딕"/>
                  <a:cs typeface="굴림"/>
                </a:rPr>
                <a:t>50℃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133289" y="2775634"/>
              <a:ext cx="4956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/>
                  <a:ea typeface="맑은 고딕"/>
                  <a:cs typeface="굴림"/>
                </a:rPr>
                <a:t>70℃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380407" y="2775634"/>
              <a:ext cx="5725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/>
                  <a:ea typeface="맑은 고딕"/>
                  <a:cs typeface="굴림"/>
                </a:rPr>
                <a:t>100℃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655354" y="2775634"/>
              <a:ext cx="5725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/>
                  <a:ea typeface="맑은 고딕"/>
                  <a:cs typeface="굴림"/>
                </a:rPr>
                <a:t>121℃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372900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7ECFDF15-B477-8A33-642D-F52D9FA5216F}"/>
              </a:ext>
            </a:extLst>
          </p:cNvPr>
          <p:cNvSpPr txBox="1"/>
          <p:nvPr/>
        </p:nvSpPr>
        <p:spPr>
          <a:xfrm>
            <a:off x="228600" y="4606111"/>
            <a:ext cx="64008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butoxybutan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different concentrations against the mycelial growth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amens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hibitory effect of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butoxybutan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growths of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topathogen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ngus under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s. PDA were used as a non-treated control. The diameter of mycelial growths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imense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PDA plates was recorded 4 days after incubation at 25°C. The experiment was performed three times in triplicates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그림 3" descr="텍스트, 도표, 라인, 폰트이(가) 표시된 사진&#10;&#10;자동 생성된 설명">
            <a:extLst>
              <a:ext uri="{FF2B5EF4-FFF2-40B4-BE49-F238E27FC236}">
                <a16:creationId xmlns:a16="http://schemas.microsoft.com/office/drawing/2014/main" id="{C75E65CF-D5A7-8D20-E0F4-7AD4F1DCD24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946913" y="533400"/>
            <a:ext cx="4745355" cy="3807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23305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18308" y="381000"/>
            <a:ext cx="6587292" cy="7149976"/>
            <a:chOff x="42108" y="381000"/>
            <a:chExt cx="6587292" cy="7149976"/>
          </a:xfrm>
        </p:grpSpPr>
        <p:grpSp>
          <p:nvGrpSpPr>
            <p:cNvPr id="4" name="Group 3"/>
            <p:cNvGrpSpPr/>
            <p:nvPr/>
          </p:nvGrpSpPr>
          <p:grpSpPr>
            <a:xfrm>
              <a:off x="304800" y="381000"/>
              <a:ext cx="6324600" cy="3886200"/>
              <a:chOff x="182880" y="1802674"/>
              <a:chExt cx="6675120" cy="4245429"/>
            </a:xfrm>
          </p:grpSpPr>
          <p:graphicFrame>
            <p:nvGraphicFramePr>
              <p:cNvPr id="5" name="차트 3">
                <a:extLst>
                  <a:ext uri="{FF2B5EF4-FFF2-40B4-BE49-F238E27FC236}">
                    <a16:creationId xmlns:a16="http://schemas.microsoft.com/office/drawing/2014/main" id="{B1BD450A-831D-5EC4-E5EC-88E8F18363DB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182880" y="1802674"/>
              <a:ext cx="6518367" cy="424542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pic>
            <p:nvPicPr>
              <p:cNvPr id="6" name="그림 4">
                <a:extLst>
                  <a:ext uri="{FF2B5EF4-FFF2-40B4-BE49-F238E27FC236}">
                    <a16:creationId xmlns:a16="http://schemas.microsoft.com/office/drawing/2014/main" id="{463149D9-8428-FCA0-7CDF-6706854A10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300447" y="2048895"/>
                <a:ext cx="2557553" cy="3561719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442AA7B7-9E39-E623-4B30-A929FFFED2BE}"/>
                  </a:ext>
                </a:extLst>
              </p:cNvPr>
              <p:cNvSpPr txBox="1"/>
              <p:nvPr/>
            </p:nvSpPr>
            <p:spPr>
              <a:xfrm>
                <a:off x="4300447" y="1802674"/>
                <a:ext cx="1761558" cy="2689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COG functional categories</a:t>
                </a:r>
                <a:endParaRPr kumimoji="0" lang="ko-KR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8" name="그림 3">
              <a:extLst>
                <a:ext uri="{FF2B5EF4-FFF2-40B4-BE49-F238E27FC236}">
                  <a16:creationId xmlns:a16="http://schemas.microsoft.com/office/drawing/2014/main" id="{E643F3AB-B509-9F0D-E5E8-A5D98CC89B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8220" r="8627"/>
            <a:stretch/>
          </p:blipFill>
          <p:spPr>
            <a:xfrm>
              <a:off x="239483" y="4191000"/>
              <a:ext cx="6389917" cy="3339976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 rot="16200000">
              <a:off x="-298513" y="2063687"/>
              <a:ext cx="11128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Number of genes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20072" y="457202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2108" y="4191000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B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29241095-20D9-B947-8FB7-26B8FCDB5F29}"/>
              </a:ext>
            </a:extLst>
          </p:cNvPr>
          <p:cNvSpPr txBox="1"/>
          <p:nvPr/>
        </p:nvSpPr>
        <p:spPr>
          <a:xfrm>
            <a:off x="161924" y="7617094"/>
            <a:ext cx="6543676" cy="8828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r>
              <a:rPr kumimoji="0" lang="en-US" altLang="ko-KR" sz="12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Gene annotation and analysis of secondary metabolites of </a:t>
            </a:r>
            <a:r>
              <a:rPr kumimoji="0" lang="en-US" altLang="ko-KR" sz="12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. </a:t>
            </a:r>
            <a:r>
              <a:rPr kumimoji="0" lang="en-US" altLang="ko-KR" sz="1200" b="1" i="1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poroverrucosus</a:t>
            </a:r>
            <a:r>
              <a:rPr kumimoji="0" lang="en-US" altLang="ko-KR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-1662. (A)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 clusters of orthologous genes (COG) function annotation of B-1662, and distribution of genes in different COG function categories. (B) Analysis of secondary metabolites of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. subtili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GYUN-2311 using the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ntiSMASH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rogram.</a:t>
            </a:r>
          </a:p>
        </p:txBody>
      </p:sp>
    </p:spTree>
    <p:extLst>
      <p:ext uri="{BB962C8B-B14F-4D97-AF65-F5344CB8AC3E}">
        <p14:creationId xmlns:p14="http://schemas.microsoft.com/office/powerpoint/2010/main" val="34020212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C6F83C4-2629-8C91-AF6F-3136FC4D09CA}"/>
              </a:ext>
            </a:extLst>
          </p:cNvPr>
          <p:cNvSpPr txBox="1"/>
          <p:nvPr/>
        </p:nvSpPr>
        <p:spPr>
          <a:xfrm>
            <a:off x="163492" y="6453063"/>
            <a:ext cx="6531015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r>
              <a:rPr lang="ko-KR" alt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ko-KR" alt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ular</a:t>
            </a:r>
            <a:r>
              <a: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ko-KR" alt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, 3, and 4 in 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tomyces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B-1662.</a:t>
            </a:r>
            <a:r>
              <a: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ular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tomyce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B-1662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ular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in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tomyce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B-1662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ular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tomyce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B-1662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ular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in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tomyce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B-1662.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ular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raw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lying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, 3, and 4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’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notatio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ult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k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racteristic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sid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nter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CDS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war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n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DS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vers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n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NA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NA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C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ent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GC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kew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783573" y="637401"/>
            <a:ext cx="5259530" cy="5434977"/>
            <a:chOff x="783573" y="637401"/>
            <a:chExt cx="5259530" cy="5434977"/>
          </a:xfrm>
        </p:grpSpPr>
        <p:pic>
          <p:nvPicPr>
            <p:cNvPr id="4" name="그림 15">
              <a:extLst>
                <a:ext uri="{FF2B5EF4-FFF2-40B4-BE49-F238E27FC236}">
                  <a16:creationId xmlns:a16="http://schemas.microsoft.com/office/drawing/2014/main" id="{6FA22B67-A6A2-2C15-E20B-C5B5762A61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70" t="1965" r="6113" b="837"/>
            <a:stretch/>
          </p:blipFill>
          <p:spPr>
            <a:xfrm>
              <a:off x="3542326" y="3393770"/>
              <a:ext cx="2500777" cy="2678608"/>
            </a:xfrm>
            <a:prstGeom prst="rect">
              <a:avLst/>
            </a:prstGeom>
          </p:spPr>
        </p:pic>
        <p:pic>
          <p:nvPicPr>
            <p:cNvPr id="5" name="그림 17">
              <a:extLst>
                <a:ext uri="{FF2B5EF4-FFF2-40B4-BE49-F238E27FC236}">
                  <a16:creationId xmlns:a16="http://schemas.microsoft.com/office/drawing/2014/main" id="{F64FE43F-836D-2CE0-D7AF-2039D09E72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905" t="4348" r="2286"/>
            <a:stretch/>
          </p:blipFill>
          <p:spPr>
            <a:xfrm>
              <a:off x="825382" y="3393770"/>
              <a:ext cx="2532212" cy="2678608"/>
            </a:xfrm>
            <a:prstGeom prst="rect">
              <a:avLst/>
            </a:prstGeom>
          </p:spPr>
        </p:pic>
        <p:pic>
          <p:nvPicPr>
            <p:cNvPr id="6" name="그림 19">
              <a:extLst>
                <a:ext uri="{FF2B5EF4-FFF2-40B4-BE49-F238E27FC236}">
                  <a16:creationId xmlns:a16="http://schemas.microsoft.com/office/drawing/2014/main" id="{503939E0-0EA2-B31A-B06E-0C2A2E9398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165"/>
            <a:stretch/>
          </p:blipFill>
          <p:spPr>
            <a:xfrm>
              <a:off x="3542327" y="670523"/>
              <a:ext cx="2500776" cy="2511068"/>
            </a:xfrm>
            <a:prstGeom prst="rect">
              <a:avLst/>
            </a:prstGeom>
          </p:spPr>
        </p:pic>
        <p:pic>
          <p:nvPicPr>
            <p:cNvPr id="7" name="그림 20">
              <a:extLst>
                <a:ext uri="{FF2B5EF4-FFF2-40B4-BE49-F238E27FC236}">
                  <a16:creationId xmlns:a16="http://schemas.microsoft.com/office/drawing/2014/main" id="{E0E421B3-1702-78C2-AE08-85EA4873CD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081" t="3772" r="2862" b="1565"/>
            <a:stretch/>
          </p:blipFill>
          <p:spPr>
            <a:xfrm>
              <a:off x="825381" y="670523"/>
              <a:ext cx="2532212" cy="2511068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488D46F-EA09-B02F-D1CD-CA75376F70FB}"/>
                </a:ext>
              </a:extLst>
            </p:cNvPr>
            <p:cNvSpPr txBox="1"/>
            <p:nvPr/>
          </p:nvSpPr>
          <p:spPr>
            <a:xfrm>
              <a:off x="794386" y="65528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F6325A7-40FC-C639-5D9C-ADD3A2400E72}"/>
                </a:ext>
              </a:extLst>
            </p:cNvPr>
            <p:cNvSpPr txBox="1"/>
            <p:nvPr/>
          </p:nvSpPr>
          <p:spPr>
            <a:xfrm>
              <a:off x="3542326" y="637401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AFFF028-6B5E-9AE6-2219-8FEC821515DA}"/>
                </a:ext>
              </a:extLst>
            </p:cNvPr>
            <p:cNvSpPr txBox="1"/>
            <p:nvPr/>
          </p:nvSpPr>
          <p:spPr>
            <a:xfrm>
              <a:off x="783573" y="334518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A733A29-6291-E32C-09FE-43719700DC4C}"/>
                </a:ext>
              </a:extLst>
            </p:cNvPr>
            <p:cNvSpPr txBox="1"/>
            <p:nvPr/>
          </p:nvSpPr>
          <p:spPr>
            <a:xfrm>
              <a:off x="3585698" y="339377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92446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667</TotalTime>
  <Words>425</Words>
  <Application>Microsoft Office PowerPoint</Application>
  <PresentationFormat>화면 슬라이드 쇼(4:3)</PresentationFormat>
  <Paragraphs>29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laraju Kotnala</dc:creator>
  <cp:lastModifiedBy>중연 김</cp:lastModifiedBy>
  <cp:revision>1040</cp:revision>
  <dcterms:created xsi:type="dcterms:W3CDTF">2006-08-16T00:00:00Z</dcterms:created>
  <dcterms:modified xsi:type="dcterms:W3CDTF">2024-10-10T14:11:53Z</dcterms:modified>
</cp:coreProperties>
</file>